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6472944-E19B-467C-99A9-36400520E6C9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617040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731200"/>
            <a:ext cx="617040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1D439A-1D40-4EFB-A147-A013EE20ED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BB282C7-BC0A-4420-A7F0-597E4E53CE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31732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31732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73120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73120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73120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9EEBA6-262D-47DE-AD91-D92BFC0A4CF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317320"/>
            <a:ext cx="617040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2BCBC93-4A99-4CD1-A03B-BA2F073DB9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617040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BE7EAE3-AD44-4193-8F56-DD4C19C5CB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72D9FC3-0C1A-4E01-8955-DF42F93EF2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F7C4FE9-3645-4A26-86E1-8076123A7C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1620720"/>
            <a:ext cx="5827680" cy="1597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6CA2F2B-02F8-46B5-849A-314D84DD23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2952C1B-699F-476B-80A7-8C6686DC27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A29D3DF-6638-40A3-85B7-E85CE4BE4C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731200"/>
            <a:ext cx="617040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4CACCC5-365A-4AEB-A670-DFD92B4D33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471600" y="9181800"/>
            <a:ext cx="154152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 Unicode MS"/>
              </a:rPr>
              <a:t>12/23/2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4843440" y="9181800"/>
            <a:ext cx="154152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B7DF25B1-3B2E-4B31-8710-AEEDFE349382}" type="slidenum">
              <a:rPr b="0" lang="en-US" sz="14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343080" y="2317320"/>
            <a:ext cx="617040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0680" y="111240"/>
            <a:ext cx="381312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 u="sng">
                <a:solidFill>
                  <a:srgbClr val="000000"/>
                </a:solidFill>
                <a:uFillTx/>
                <a:latin typeface="Calibri"/>
              </a:rPr>
              <a:t>Supplemental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54040" y="768240"/>
            <a:ext cx="4611600" cy="927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marL="169920" indent="-169920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Breast cancer patients during the first wave of the COVID-19 pandemic: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in a neoadjuvant, adjuvant or palliative sett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treated either on an outpateint or inpatient ba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receiving sequencing endocrine therapy, targeted therapy and / or chemotherapy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76360" y="2233440"/>
            <a:ext cx="2501640" cy="2577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Willingness to participate in the study?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82480" y="2922480"/>
            <a:ext cx="2502000" cy="12621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marL="169920" indent="-169920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Met the inclusion criteria?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ge of 18-80 year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o known infection with SARS-CoV-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ufficient knowledge of the German language to folllow study information and questionnair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bility to give cons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76360" y="4522680"/>
            <a:ext cx="2501640" cy="5925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Written informed consent after receiving verbal and written information by the oncological medical doctors?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125960" y="2259000"/>
            <a:ext cx="403200" cy="10029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EXCLU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76360" y="6423120"/>
            <a:ext cx="2817720" cy="4251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Throat swab  for SARS-CoV-2 and blood colle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76360" y="6907320"/>
            <a:ext cx="2819160" cy="19317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marL="169920" indent="-169920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Questionnair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COVID-19 pandemic questionnair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Stress and Coping Inventory (SCI) [19]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National Comprehensive Cancer Network® (NCCN®) Distress Thermometer (DT) [20]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European Organization for Research and Treatment of Cancer (EORTC) QLQ C30 and the BR23 [17, 21]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marL="169920" indent="-169920">
              <a:lnSpc>
                <a:spcPct val="100000"/>
              </a:lnSpc>
              <a:buClr>
                <a:srgbClr val="000000"/>
              </a:buClr>
              <a:buSzPct val="45000"/>
              <a:buFont typeface="Arial"/>
              <a:buChar char="•"/>
              <a:tabLst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Questionnaires filled out by the patients themselves during the therapy stay in the treatment and/or hospital room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76360" y="8943840"/>
            <a:ext cx="2819160" cy="5925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Information on the patient's state of health and the course of breast cancer from medical record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365720" y="7091280"/>
            <a:ext cx="1271520" cy="1764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Data colle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Data were collected, entered into an Excel spreadsheet under the corresponding study number, and analysed via  SPSS Statistics 26 (IBM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620720" y="2589120"/>
            <a:ext cx="276480" cy="300240"/>
          </a:xfrm>
          <a:prstGeom prst="downArrow">
            <a:avLst>
              <a:gd name="adj1" fmla="val 50000"/>
              <a:gd name="adj2" fmla="val 27148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625760" y="4238640"/>
            <a:ext cx="264960" cy="250920"/>
          </a:xfrm>
          <a:prstGeom prst="downArrow">
            <a:avLst>
              <a:gd name="adj1" fmla="val 50000"/>
              <a:gd name="adj2" fmla="val 25000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625760" y="5159520"/>
            <a:ext cx="258480" cy="258480"/>
          </a:xfrm>
          <a:prstGeom prst="downArrow">
            <a:avLst>
              <a:gd name="adj1" fmla="val 50000"/>
              <a:gd name="adj2" fmla="val 25000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635120" y="1754280"/>
            <a:ext cx="262080" cy="438120"/>
          </a:xfrm>
          <a:prstGeom prst="downArrow">
            <a:avLst>
              <a:gd name="adj1" fmla="val 50000"/>
              <a:gd name="adj2" fmla="val 41793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5" name=""/>
          <p:cNvCxnSpPr/>
          <p:nvPr/>
        </p:nvCxnSpPr>
        <p:spPr>
          <a:xfrm flipH="1" rot="16200000">
            <a:off x="3357720" y="6841080"/>
            <a:ext cx="1033920" cy="735840"/>
          </a:xfrm>
          <a:prstGeom prst="bentConnector3">
            <a:avLst>
              <a:gd name="adj1" fmla="val 50017"/>
            </a:avLst>
          </a:prstGeom>
          <a:ln w="38160">
            <a:solidFill>
              <a:srgbClr val="a5a5a5"/>
            </a:solidFill>
            <a:miter/>
            <a:tailEnd len="med" type="triangle" w="med"/>
          </a:ln>
        </p:spPr>
      </p:cxnSp>
      <p:cxnSp>
        <p:nvCxnSpPr>
          <p:cNvPr id="56" name=""/>
          <p:cNvCxnSpPr/>
          <p:nvPr/>
        </p:nvCxnSpPr>
        <p:spPr>
          <a:xfrm>
            <a:off x="3531960" y="7837200"/>
            <a:ext cx="711720" cy="13320"/>
          </a:xfrm>
          <a:prstGeom prst="bentConnector3">
            <a:avLst>
              <a:gd name="adj1" fmla="val 50000"/>
            </a:avLst>
          </a:prstGeom>
          <a:ln w="38160">
            <a:solidFill>
              <a:srgbClr val="a5a5a5"/>
            </a:solidFill>
            <a:miter/>
            <a:tailEnd len="med" type="triangle" w="med"/>
          </a:ln>
        </p:spPr>
      </p:cxnSp>
      <p:cxnSp>
        <p:nvCxnSpPr>
          <p:cNvPr id="57" name=""/>
          <p:cNvCxnSpPr/>
          <p:nvPr/>
        </p:nvCxnSpPr>
        <p:spPr>
          <a:xfrm flipH="1" flipV="1" rot="5400000">
            <a:off x="3285000" y="8195040"/>
            <a:ext cx="1180080" cy="775440"/>
          </a:xfrm>
          <a:prstGeom prst="bentConnector3">
            <a:avLst>
              <a:gd name="adj1" fmla="val 49984"/>
            </a:avLst>
          </a:prstGeom>
          <a:ln w="38160">
            <a:solidFill>
              <a:srgbClr val="a5a5a5"/>
            </a:solidFill>
            <a:miter/>
            <a:tailEnd len="med" type="triangle" w="med"/>
          </a:ln>
        </p:spPr>
      </p:cxnSp>
      <p:sp>
        <p:nvSpPr>
          <p:cNvPr id="58" name=""/>
          <p:cNvSpPr/>
          <p:nvPr/>
        </p:nvSpPr>
        <p:spPr>
          <a:xfrm>
            <a:off x="1897200" y="2565360"/>
            <a:ext cx="50328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874880" y="4222800"/>
            <a:ext cx="50328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889280" y="5116680"/>
            <a:ext cx="50292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22800" y="2062080"/>
            <a:ext cx="50292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3440160" y="2072880"/>
            <a:ext cx="276120" cy="600120"/>
          </a:xfrm>
          <a:prstGeom prst="downArrow">
            <a:avLst>
              <a:gd name="adj1" fmla="val 50000"/>
              <a:gd name="adj2" fmla="val 54335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316320" y="3213000"/>
            <a:ext cx="50328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6200000">
            <a:off x="3433320" y="3249360"/>
            <a:ext cx="276480" cy="600120"/>
          </a:xfrm>
          <a:prstGeom prst="downArrow">
            <a:avLst>
              <a:gd name="adj1" fmla="val 50000"/>
              <a:gd name="adj2" fmla="val 54264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316320" y="4468680"/>
            <a:ext cx="503280" cy="25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3433680" y="4528800"/>
            <a:ext cx="276120" cy="600120"/>
          </a:xfrm>
          <a:prstGeom prst="downArrow">
            <a:avLst>
              <a:gd name="adj1" fmla="val 50000"/>
              <a:gd name="adj2" fmla="val 54335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76360" y="5454720"/>
            <a:ext cx="2817720" cy="5925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llocation of a corresponding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tudy number (documented on the main clinical record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35120" y="6119640"/>
            <a:ext cx="258840" cy="258840"/>
          </a:xfrm>
          <a:prstGeom prst="downArrow">
            <a:avLst>
              <a:gd name="adj1" fmla="val 50000"/>
              <a:gd name="adj2" fmla="val 25000"/>
            </a:avLst>
          </a:prstGeom>
          <a:solidFill>
            <a:srgbClr val="e7e6e6"/>
          </a:solidFill>
          <a:ln w="12600">
            <a:solidFill>
              <a:srgbClr val="7a7a7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